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477" r:id="rId2"/>
    <p:sldId id="467" r:id="rId3"/>
    <p:sldId id="478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0000"/>
    <a:srgbClr val="FF0A0A"/>
    <a:srgbClr val="00008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9228A3B-A688-47B0-BDC2-F4FCFB1F0831}" v="104" dt="2025-09-03T20:30:27.19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39" d="100"/>
          <a:sy n="39" d="100"/>
        </p:scale>
        <p:origin x="25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ore, Eric A (HSC)" userId="f877c6f6-52fb-4657-bd5a-d2b37bd0206f" providerId="ADAL" clId="{B9228A3B-A688-47B0-BDC2-F4FCFB1F0831}"/>
    <pc:docChg chg="undo custSel modSld">
      <pc:chgData name="Moore, Eric A (HSC)" userId="f877c6f6-52fb-4657-bd5a-d2b37bd0206f" providerId="ADAL" clId="{B9228A3B-A688-47B0-BDC2-F4FCFB1F0831}" dt="2025-09-03T20:31:07.614" v="368" actId="1036"/>
      <pc:docMkLst>
        <pc:docMk/>
      </pc:docMkLst>
      <pc:sldChg chg="addSp delSp modSp mod">
        <pc:chgData name="Moore, Eric A (HSC)" userId="f877c6f6-52fb-4657-bd5a-d2b37bd0206f" providerId="ADAL" clId="{B9228A3B-A688-47B0-BDC2-F4FCFB1F0831}" dt="2025-09-03T20:31:07.614" v="368" actId="1036"/>
        <pc:sldMkLst>
          <pc:docMk/>
          <pc:sldMk cId="3310083469" sldId="467"/>
        </pc:sldMkLst>
        <pc:spChg chg="mod">
          <ac:chgData name="Moore, Eric A (HSC)" userId="f877c6f6-52fb-4657-bd5a-d2b37bd0206f" providerId="ADAL" clId="{B9228A3B-A688-47B0-BDC2-F4FCFB1F0831}" dt="2025-09-03T20:29:39.500" v="341" actId="14100"/>
          <ac:spMkLst>
            <pc:docMk/>
            <pc:sldMk cId="3310083469" sldId="467"/>
            <ac:spMk id="3" creationId="{4880AA41-3F5B-4A6A-89FA-A25BD5ED0E60}"/>
          </ac:spMkLst>
        </pc:spChg>
        <pc:spChg chg="add del mod">
          <ac:chgData name="Moore, Eric A (HSC)" userId="f877c6f6-52fb-4657-bd5a-d2b37bd0206f" providerId="ADAL" clId="{B9228A3B-A688-47B0-BDC2-F4FCFB1F0831}" dt="2025-09-03T19:33:12.569" v="268" actId="478"/>
          <ac:spMkLst>
            <pc:docMk/>
            <pc:sldMk cId="3310083469" sldId="467"/>
            <ac:spMk id="4" creationId="{625934A0-EC18-01B6-A1D3-DB4514D112BD}"/>
          </ac:spMkLst>
        </pc:spChg>
        <pc:spChg chg="mod">
          <ac:chgData name="Moore, Eric A (HSC)" userId="f877c6f6-52fb-4657-bd5a-d2b37bd0206f" providerId="ADAL" clId="{B9228A3B-A688-47B0-BDC2-F4FCFB1F0831}" dt="2025-09-03T20:27:38.911" v="286" actId="1036"/>
          <ac:spMkLst>
            <pc:docMk/>
            <pc:sldMk cId="3310083469" sldId="467"/>
            <ac:spMk id="5" creationId="{00000000-0000-0000-0000-000000000000}"/>
          </ac:spMkLst>
        </pc:spChg>
        <pc:spChg chg="mod">
          <ac:chgData name="Moore, Eric A (HSC)" userId="f877c6f6-52fb-4657-bd5a-d2b37bd0206f" providerId="ADAL" clId="{B9228A3B-A688-47B0-BDC2-F4FCFB1F0831}" dt="2025-09-03T20:27:38.911" v="286" actId="1036"/>
          <ac:spMkLst>
            <pc:docMk/>
            <pc:sldMk cId="3310083469" sldId="467"/>
            <ac:spMk id="6" creationId="{00000000-0000-0000-0000-000000000000}"/>
          </ac:spMkLst>
        </pc:spChg>
        <pc:spChg chg="add del mod">
          <ac:chgData name="Moore, Eric A (HSC)" userId="f877c6f6-52fb-4657-bd5a-d2b37bd0206f" providerId="ADAL" clId="{B9228A3B-A688-47B0-BDC2-F4FCFB1F0831}" dt="2025-09-03T19:33:13.720" v="269" actId="478"/>
          <ac:spMkLst>
            <pc:docMk/>
            <pc:sldMk cId="3310083469" sldId="467"/>
            <ac:spMk id="7" creationId="{555EA0B1-B234-7605-71A5-93F75383FE71}"/>
          </ac:spMkLst>
        </pc:spChg>
        <pc:spChg chg="del">
          <ac:chgData name="Moore, Eric A (HSC)" userId="f877c6f6-52fb-4657-bd5a-d2b37bd0206f" providerId="ADAL" clId="{B9228A3B-A688-47B0-BDC2-F4FCFB1F0831}" dt="2025-09-02T21:35:19.414" v="3" actId="478"/>
          <ac:spMkLst>
            <pc:docMk/>
            <pc:sldMk cId="3310083469" sldId="467"/>
            <ac:spMk id="7" creationId="{DC53D282-7F02-A6FE-52B5-0F0784BF7246}"/>
          </ac:spMkLst>
        </pc:spChg>
        <pc:spChg chg="add del mod">
          <ac:chgData name="Moore, Eric A (HSC)" userId="f877c6f6-52fb-4657-bd5a-d2b37bd0206f" providerId="ADAL" clId="{B9228A3B-A688-47B0-BDC2-F4FCFB1F0831}" dt="2025-09-03T19:33:14.654" v="270" actId="478"/>
          <ac:spMkLst>
            <pc:docMk/>
            <pc:sldMk cId="3310083469" sldId="467"/>
            <ac:spMk id="8" creationId="{80614B98-42C6-17FA-37C0-AA350743D766}"/>
          </ac:spMkLst>
        </pc:spChg>
        <pc:spChg chg="del">
          <ac:chgData name="Moore, Eric A (HSC)" userId="f877c6f6-52fb-4657-bd5a-d2b37bd0206f" providerId="ADAL" clId="{B9228A3B-A688-47B0-BDC2-F4FCFB1F0831}" dt="2025-09-02T21:35:41.297" v="7" actId="478"/>
          <ac:spMkLst>
            <pc:docMk/>
            <pc:sldMk cId="3310083469" sldId="467"/>
            <ac:spMk id="8" creationId="{A0AFC593-B5CB-04A1-D633-DF368FD5A9A4}"/>
          </ac:spMkLst>
        </pc:spChg>
        <pc:spChg chg="del">
          <ac:chgData name="Moore, Eric A (HSC)" userId="f877c6f6-52fb-4657-bd5a-d2b37bd0206f" providerId="ADAL" clId="{B9228A3B-A688-47B0-BDC2-F4FCFB1F0831}" dt="2025-09-02T21:38:36.294" v="55" actId="478"/>
          <ac:spMkLst>
            <pc:docMk/>
            <pc:sldMk cId="3310083469" sldId="467"/>
            <ac:spMk id="9" creationId="{4A734B9A-88A5-D086-3674-3C215B29B7F1}"/>
          </ac:spMkLst>
        </pc:spChg>
        <pc:spChg chg="add del mod">
          <ac:chgData name="Moore, Eric A (HSC)" userId="f877c6f6-52fb-4657-bd5a-d2b37bd0206f" providerId="ADAL" clId="{B9228A3B-A688-47B0-BDC2-F4FCFB1F0831}" dt="2025-09-03T19:33:16.322" v="272" actId="478"/>
          <ac:spMkLst>
            <pc:docMk/>
            <pc:sldMk cId="3310083469" sldId="467"/>
            <ac:spMk id="9" creationId="{C41B0B57-0C74-7736-EBC7-2DA7CFF49E79}"/>
          </ac:spMkLst>
        </pc:spChg>
        <pc:spChg chg="mod">
          <ac:chgData name="Moore, Eric A (HSC)" userId="f877c6f6-52fb-4657-bd5a-d2b37bd0206f" providerId="ADAL" clId="{B9228A3B-A688-47B0-BDC2-F4FCFB1F0831}" dt="2025-09-03T20:29:39.500" v="341" actId="14100"/>
          <ac:spMkLst>
            <pc:docMk/>
            <pc:sldMk cId="3310083469" sldId="467"/>
            <ac:spMk id="10" creationId="{FB338E90-D4FB-4326-B1E6-28C7B154B698}"/>
          </ac:spMkLst>
        </pc:spChg>
        <pc:spChg chg="mod">
          <ac:chgData name="Moore, Eric A (HSC)" userId="f877c6f6-52fb-4657-bd5a-d2b37bd0206f" providerId="ADAL" clId="{B9228A3B-A688-47B0-BDC2-F4FCFB1F0831}" dt="2025-09-03T20:27:38.911" v="286" actId="1036"/>
          <ac:spMkLst>
            <pc:docMk/>
            <pc:sldMk cId="3310083469" sldId="467"/>
            <ac:spMk id="22" creationId="{67130B01-E052-DC5B-D613-1333D8853918}"/>
          </ac:spMkLst>
        </pc:spChg>
        <pc:spChg chg="mod">
          <ac:chgData name="Moore, Eric A (HSC)" userId="f877c6f6-52fb-4657-bd5a-d2b37bd0206f" providerId="ADAL" clId="{B9228A3B-A688-47B0-BDC2-F4FCFB1F0831}" dt="2025-09-03T20:27:38.911" v="286" actId="1036"/>
          <ac:spMkLst>
            <pc:docMk/>
            <pc:sldMk cId="3310083469" sldId="467"/>
            <ac:spMk id="26" creationId="{00000000-0000-0000-0000-000000000000}"/>
          </ac:spMkLst>
        </pc:spChg>
        <pc:spChg chg="mod">
          <ac:chgData name="Moore, Eric A (HSC)" userId="f877c6f6-52fb-4657-bd5a-d2b37bd0206f" providerId="ADAL" clId="{B9228A3B-A688-47B0-BDC2-F4FCFB1F0831}" dt="2025-09-03T20:27:38.911" v="286" actId="1036"/>
          <ac:spMkLst>
            <pc:docMk/>
            <pc:sldMk cId="3310083469" sldId="467"/>
            <ac:spMk id="27" creationId="{00000000-0000-0000-0000-000000000000}"/>
          </ac:spMkLst>
        </pc:spChg>
        <pc:graphicFrameChg chg="mod">
          <ac:chgData name="Moore, Eric A (HSC)" userId="f877c6f6-52fb-4657-bd5a-d2b37bd0206f" providerId="ADAL" clId="{B9228A3B-A688-47B0-BDC2-F4FCFB1F0831}" dt="2025-09-03T20:30:36.107" v="348" actId="555"/>
          <ac:graphicFrameMkLst>
            <pc:docMk/>
            <pc:sldMk cId="3310083469" sldId="467"/>
            <ac:graphicFrameMk id="12" creationId="{867C5188-FCDF-64A3-6368-85F45E6F84AB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3T20:30:36.107" v="348" actId="555"/>
          <ac:graphicFrameMkLst>
            <pc:docMk/>
            <pc:sldMk cId="3310083469" sldId="467"/>
            <ac:graphicFrameMk id="18" creationId="{D21DABD3-40BA-B153-20E2-5EB2CA3A7E3C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3T20:31:03.238" v="361" actId="1036"/>
          <ac:graphicFrameMkLst>
            <pc:docMk/>
            <pc:sldMk cId="3310083469" sldId="467"/>
            <ac:graphicFrameMk id="19" creationId="{C7D574C3-172E-57B3-C377-CAA6A6714535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3T20:31:03.238" v="361" actId="1036"/>
          <ac:graphicFrameMkLst>
            <pc:docMk/>
            <pc:sldMk cId="3310083469" sldId="467"/>
            <ac:graphicFrameMk id="20" creationId="{742ECFEF-DA25-C9FF-9787-A1E01FE7534D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3T20:31:07.614" v="368" actId="1036"/>
          <ac:graphicFrameMkLst>
            <pc:docMk/>
            <pc:sldMk cId="3310083469" sldId="467"/>
            <ac:graphicFrameMk id="21" creationId="{BEAB4919-A124-6B56-C774-AD8FC9961764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3T20:31:07.614" v="368" actId="1036"/>
          <ac:graphicFrameMkLst>
            <pc:docMk/>
            <pc:sldMk cId="3310083469" sldId="467"/>
            <ac:graphicFrameMk id="23" creationId="{9AD345B5-04D4-939D-CD57-EAE9FDE68BD2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3T20:30:57.988" v="353" actId="1036"/>
          <ac:graphicFrameMkLst>
            <pc:docMk/>
            <pc:sldMk cId="3310083469" sldId="467"/>
            <ac:graphicFrameMk id="24" creationId="{61176ACF-6C9C-7CD8-F3B9-272D12822455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3T20:30:57.988" v="353" actId="1036"/>
          <ac:graphicFrameMkLst>
            <pc:docMk/>
            <pc:sldMk cId="3310083469" sldId="467"/>
            <ac:graphicFrameMk id="25" creationId="{FD876207-8C12-E16E-5111-AF1445335AB5}"/>
          </ac:graphicFrameMkLst>
        </pc:graphicFrameChg>
      </pc:sldChg>
      <pc:sldChg chg="modSp mod">
        <pc:chgData name="Moore, Eric A (HSC)" userId="f877c6f6-52fb-4657-bd5a-d2b37bd0206f" providerId="ADAL" clId="{B9228A3B-A688-47B0-BDC2-F4FCFB1F0831}" dt="2025-09-03T19:26:30.669" v="236" actId="1076"/>
        <pc:sldMkLst>
          <pc:docMk/>
          <pc:sldMk cId="1706268784" sldId="477"/>
        </pc:sldMkLst>
        <pc:spChg chg="mod">
          <ac:chgData name="Moore, Eric A (HSC)" userId="f877c6f6-52fb-4657-bd5a-d2b37bd0206f" providerId="ADAL" clId="{B9228A3B-A688-47B0-BDC2-F4FCFB1F0831}" dt="2025-09-03T19:26:30.669" v="236" actId="1076"/>
          <ac:spMkLst>
            <pc:docMk/>
            <pc:sldMk cId="1706268784" sldId="477"/>
            <ac:spMk id="8" creationId="{B3C8A945-6C03-C79E-00AD-10C13F6B89CF}"/>
          </ac:spMkLst>
        </pc:spChg>
        <pc:grpChg chg="mod">
          <ac:chgData name="Moore, Eric A (HSC)" userId="f877c6f6-52fb-4657-bd5a-d2b37bd0206f" providerId="ADAL" clId="{B9228A3B-A688-47B0-BDC2-F4FCFB1F0831}" dt="2025-09-02T21:38:29.414" v="54"/>
          <ac:grpSpMkLst>
            <pc:docMk/>
            <pc:sldMk cId="1706268784" sldId="477"/>
            <ac:grpSpMk id="16" creationId="{395D754E-3348-331E-5A3C-5BF15ECB86D7}"/>
          </ac:grpSpMkLst>
        </pc:grpChg>
        <pc:graphicFrameChg chg="mod">
          <ac:chgData name="Moore, Eric A (HSC)" userId="f877c6f6-52fb-4657-bd5a-d2b37bd0206f" providerId="ADAL" clId="{B9228A3B-A688-47B0-BDC2-F4FCFB1F0831}" dt="2025-09-02T21:38:29.414" v="54"/>
          <ac:graphicFrameMkLst>
            <pc:docMk/>
            <pc:sldMk cId="1706268784" sldId="477"/>
            <ac:graphicFrameMk id="2" creationId="{E3CCFFA3-85DA-D341-6341-72D978C2A3B8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2T21:38:29.414" v="54"/>
          <ac:graphicFrameMkLst>
            <pc:docMk/>
            <pc:sldMk cId="1706268784" sldId="477"/>
            <ac:graphicFrameMk id="4" creationId="{6F65395F-823A-D190-BA31-399965A54A21}"/>
          </ac:graphicFrameMkLst>
        </pc:graphicFrameChg>
        <pc:graphicFrameChg chg="modGraphic">
          <ac:chgData name="Moore, Eric A (HSC)" userId="f877c6f6-52fb-4657-bd5a-d2b37bd0206f" providerId="ADAL" clId="{B9228A3B-A688-47B0-BDC2-F4FCFB1F0831}" dt="2025-09-03T19:26:27.521" v="235" actId="2165"/>
          <ac:graphicFrameMkLst>
            <pc:docMk/>
            <pc:sldMk cId="1706268784" sldId="477"/>
            <ac:graphicFrameMk id="9" creationId="{00000000-0000-0000-0000-000000000000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2T21:38:29.414" v="54"/>
          <ac:graphicFrameMkLst>
            <pc:docMk/>
            <pc:sldMk cId="1706268784" sldId="477"/>
            <ac:graphicFrameMk id="10" creationId="{7F381A4A-B1B5-E328-355B-14F9672A2858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2T21:38:29.414" v="54"/>
          <ac:graphicFrameMkLst>
            <pc:docMk/>
            <pc:sldMk cId="1706268784" sldId="477"/>
            <ac:graphicFrameMk id="11" creationId="{D39A4312-C8A4-D4E0-2849-29103E0FA947}"/>
          </ac:graphicFrameMkLst>
        </pc:graphicFrameChg>
        <pc:graphicFrameChg chg="mod">
          <ac:chgData name="Moore, Eric A (HSC)" userId="f877c6f6-52fb-4657-bd5a-d2b37bd0206f" providerId="ADAL" clId="{B9228A3B-A688-47B0-BDC2-F4FCFB1F0831}" dt="2025-09-02T21:38:29.414" v="54"/>
          <ac:graphicFrameMkLst>
            <pc:docMk/>
            <pc:sldMk cId="1706268784" sldId="477"/>
            <ac:graphicFrameMk id="12" creationId="{4830F828-CEF2-933D-E94E-87E2E786DE6B}"/>
          </ac:graphicFrameMkLst>
        </pc:graphicFrame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BB5EC4-E320-4755-AD2E-C286B83A460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DCA0C7-C402-4E9C-8BAC-068286166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1132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2827CD-6AB9-487F-9AA0-34C86DC3FA8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0234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084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536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768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211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305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519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712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008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506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915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655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E87C0A-5E01-49D4-B9A1-6CC3B98C9D2B}" type="datetimeFigureOut">
              <a:rPr lang="en-US" smtClean="0"/>
              <a:t>2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3A1846-2BAE-4E03-83E3-988C6D939A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701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image" Target="../media/image6.png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11.emf"/><Relationship Id="rId18" Type="http://schemas.openxmlformats.org/officeDocument/2006/relationships/oleObject" Target="../embeddings/oleObject1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8.emf"/><Relationship Id="rId12" Type="http://schemas.openxmlformats.org/officeDocument/2006/relationships/oleObject" Target="../embeddings/oleObject10.bin"/><Relationship Id="rId17" Type="http://schemas.openxmlformats.org/officeDocument/2006/relationships/image" Target="../media/image13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2.bin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0.emf"/><Relationship Id="rId5" Type="http://schemas.openxmlformats.org/officeDocument/2006/relationships/image" Target="../media/image7.emf"/><Relationship Id="rId15" Type="http://schemas.openxmlformats.org/officeDocument/2006/relationships/image" Target="../media/image12.emf"/><Relationship Id="rId10" Type="http://schemas.openxmlformats.org/officeDocument/2006/relationships/oleObject" Target="../embeddings/oleObject9.bin"/><Relationship Id="rId19" Type="http://schemas.openxmlformats.org/officeDocument/2006/relationships/image" Target="../media/image14.emf"/><Relationship Id="rId4" Type="http://schemas.openxmlformats.org/officeDocument/2006/relationships/oleObject" Target="../embeddings/oleObject6.bin"/><Relationship Id="rId9" Type="http://schemas.openxmlformats.org/officeDocument/2006/relationships/image" Target="../media/image9.emf"/><Relationship Id="rId14" Type="http://schemas.openxmlformats.org/officeDocument/2006/relationships/oleObject" Target="../embeddings/oleObject11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3623859-E15C-3CAB-AF18-99741EA3F23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11801" y="270127"/>
            <a:ext cx="6297270" cy="440808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57E1612D-5873-AB5A-5BB6-ED2CE3ABB725}"/>
              </a:ext>
            </a:extLst>
          </p:cNvPr>
          <p:cNvSpPr/>
          <p:nvPr/>
        </p:nvSpPr>
        <p:spPr>
          <a:xfrm>
            <a:off x="0" y="8964801"/>
            <a:ext cx="656014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Experimental desig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6E407E-7106-F97C-5914-17C7E5666796}"/>
              </a:ext>
            </a:extLst>
          </p:cNvPr>
          <p:cNvSpPr txBox="1"/>
          <p:nvPr/>
        </p:nvSpPr>
        <p:spPr>
          <a:xfrm>
            <a:off x="324202" y="47976"/>
            <a:ext cx="105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95D754E-3348-331E-5A3C-5BF15ECB86D7}"/>
              </a:ext>
            </a:extLst>
          </p:cNvPr>
          <p:cNvGrpSpPr/>
          <p:nvPr/>
        </p:nvGrpSpPr>
        <p:grpSpPr>
          <a:xfrm>
            <a:off x="1150938" y="5176838"/>
            <a:ext cx="4554537" cy="3816350"/>
            <a:chOff x="832330" y="5772312"/>
            <a:chExt cx="5258089" cy="4264900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E3CCFFA3-85DA-D341-6341-72D978C2A3B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38017034"/>
                </p:ext>
              </p:extLst>
            </p:nvPr>
          </p:nvGraphicFramePr>
          <p:xfrm>
            <a:off x="832330" y="5772312"/>
            <a:ext cx="1746587" cy="21218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Prism 10" r:id="rId4" imgW="2325305" imgH="2825339" progId="Prism10.Document">
                    <p:embed/>
                  </p:oleObj>
                </mc:Choice>
                <mc:Fallback>
                  <p:oleObj name="Prism 10" r:id="rId4" imgW="2325305" imgH="2825339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E3CCFFA3-85DA-D341-6341-72D978C2A3B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832330" y="5772312"/>
                          <a:ext cx="1746587" cy="21218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6F65395F-823A-D190-BA31-399965A54A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11218839"/>
                </p:ext>
              </p:extLst>
            </p:nvPr>
          </p:nvGraphicFramePr>
          <p:xfrm>
            <a:off x="2588081" y="5791826"/>
            <a:ext cx="1746587" cy="210229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2" name="Prism 10" r:id="rId6" imgW="2325305" imgH="2797622" progId="Prism10.Document">
                    <p:embed/>
                  </p:oleObj>
                </mc:Choice>
                <mc:Fallback>
                  <p:oleObj name="Prism 10" r:id="rId6" imgW="2325305" imgH="2797622" progId="Prism10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6F65395F-823A-D190-BA31-399965A54A2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588081" y="5791826"/>
                          <a:ext cx="1746587" cy="210229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7F381A4A-B1B5-E328-355B-14F9672A285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80961332"/>
                </p:ext>
              </p:extLst>
            </p:nvPr>
          </p:nvGraphicFramePr>
          <p:xfrm>
            <a:off x="4343832" y="5786505"/>
            <a:ext cx="1746587" cy="21076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3" name="Prism 10" r:id="rId8" imgW="2325305" imgH="2806981" progId="Prism10.Document">
                    <p:embed/>
                  </p:oleObj>
                </mc:Choice>
                <mc:Fallback>
                  <p:oleObj name="Prism 10" r:id="rId8" imgW="2325305" imgH="2806981" progId="Prism10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7F381A4A-B1B5-E328-355B-14F9672A285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343832" y="5786505"/>
                          <a:ext cx="1746587" cy="21076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D39A4312-C8A4-D4E0-2849-29103E0FA94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75722178"/>
                </p:ext>
              </p:extLst>
            </p:nvPr>
          </p:nvGraphicFramePr>
          <p:xfrm>
            <a:off x="1572751" y="7942017"/>
            <a:ext cx="1746587" cy="209519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4" name="Prism 10" r:id="rId10" imgW="2325305" imgH="2788623" progId="Prism10.Document">
                    <p:embed/>
                  </p:oleObj>
                </mc:Choice>
                <mc:Fallback>
                  <p:oleObj name="Prism 10" r:id="rId10" imgW="2325305" imgH="2788623" progId="Prism10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D39A4312-C8A4-D4E0-2849-29103E0FA94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572751" y="7942017"/>
                          <a:ext cx="1746587" cy="209519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4830F828-CEF2-933D-E94E-87E2E786DE6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54469505"/>
                </p:ext>
              </p:extLst>
            </p:nvPr>
          </p:nvGraphicFramePr>
          <p:xfrm>
            <a:off x="3366989" y="7963306"/>
            <a:ext cx="1746588" cy="20739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5" name="Prism 10" r:id="rId12" imgW="2325305" imgH="2761266" progId="Prism10.Document">
                    <p:embed/>
                  </p:oleObj>
                </mc:Choice>
                <mc:Fallback>
                  <p:oleObj name="Prism 10" r:id="rId12" imgW="2325305" imgH="2761266" progId="Prism10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4830F828-CEF2-933D-E94E-87E2E786DE6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366989" y="7963306"/>
                          <a:ext cx="1746588" cy="20739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3824FDC7-828C-D17E-4EDE-EF3B2F014460}"/>
              </a:ext>
            </a:extLst>
          </p:cNvPr>
          <p:cNvSpPr txBox="1"/>
          <p:nvPr/>
        </p:nvSpPr>
        <p:spPr>
          <a:xfrm>
            <a:off x="328207" y="3421605"/>
            <a:ext cx="105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DC9F50E-3636-4F22-70E2-919C43C5253A}"/>
              </a:ext>
            </a:extLst>
          </p:cNvPr>
          <p:cNvSpPr txBox="1"/>
          <p:nvPr/>
        </p:nvSpPr>
        <p:spPr>
          <a:xfrm>
            <a:off x="336394" y="4910150"/>
            <a:ext cx="105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8406779"/>
              </p:ext>
            </p:extLst>
          </p:nvPr>
        </p:nvGraphicFramePr>
        <p:xfrm>
          <a:off x="459644" y="3715182"/>
          <a:ext cx="5686883" cy="676138"/>
        </p:xfrm>
        <a:graphic>
          <a:graphicData uri="http://schemas.openxmlformats.org/drawingml/2006/table">
            <a:tbl>
              <a:tblPr/>
              <a:tblGrid>
                <a:gridCol w="1773984">
                  <a:extLst>
                    <a:ext uri="{9D8B030D-6E8A-4147-A177-3AD203B41FA5}">
                      <a16:colId xmlns:a16="http://schemas.microsoft.com/office/drawing/2014/main" val="490572303"/>
                    </a:ext>
                  </a:extLst>
                </a:gridCol>
                <a:gridCol w="559314">
                  <a:extLst>
                    <a:ext uri="{9D8B030D-6E8A-4147-A177-3AD203B41FA5}">
                      <a16:colId xmlns:a16="http://schemas.microsoft.com/office/drawing/2014/main" val="3075756545"/>
                    </a:ext>
                  </a:extLst>
                </a:gridCol>
                <a:gridCol w="1192895">
                  <a:extLst>
                    <a:ext uri="{9D8B030D-6E8A-4147-A177-3AD203B41FA5}">
                      <a16:colId xmlns:a16="http://schemas.microsoft.com/office/drawing/2014/main" val="3865219032"/>
                    </a:ext>
                  </a:extLst>
                </a:gridCol>
                <a:gridCol w="432396">
                  <a:extLst>
                    <a:ext uri="{9D8B030D-6E8A-4147-A177-3AD203B41FA5}">
                      <a16:colId xmlns:a16="http://schemas.microsoft.com/office/drawing/2014/main" val="2044107118"/>
                    </a:ext>
                  </a:extLst>
                </a:gridCol>
                <a:gridCol w="1008795">
                  <a:extLst>
                    <a:ext uri="{9D8B030D-6E8A-4147-A177-3AD203B41FA5}">
                      <a16:colId xmlns:a16="http://schemas.microsoft.com/office/drawing/2014/main" val="409635793"/>
                    </a:ext>
                  </a:extLst>
                </a:gridCol>
                <a:gridCol w="719499">
                  <a:extLst>
                    <a:ext uri="{9D8B030D-6E8A-4147-A177-3AD203B41FA5}">
                      <a16:colId xmlns:a16="http://schemas.microsoft.com/office/drawing/2014/main" val="235946949"/>
                    </a:ext>
                  </a:extLst>
                </a:gridCol>
              </a:tblGrid>
              <a:tr h="171568">
                <a:tc rowSpan="2">
                  <a:txBody>
                    <a:bodyPr/>
                    <a:lstStyle/>
                    <a:p>
                      <a:pPr algn="ctr" fontAlgn="b">
                        <a:spcBef>
                          <a:spcPts val="1200"/>
                        </a:spcBef>
                      </a:pPr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ets</a:t>
                      </a:r>
                    </a:p>
                    <a:p>
                      <a:pPr algn="ctr" fontAlgn="b"/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170" marR="8170" marT="81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nutrient Composition (% by weight)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5603458"/>
                  </a:ext>
                </a:extLst>
              </a:tr>
              <a:tr h="1633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</a:p>
                  </a:txBody>
                  <a:tcPr marL="8170" marR="8170" marT="81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hydrate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*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lesterol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rose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8009425"/>
                  </a:ext>
                </a:extLst>
              </a:tr>
              <a:tr h="16339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coLab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odent Diet 20</a:t>
                      </a:r>
                    </a:p>
                  </a:txBody>
                  <a:tcPr marL="8170" marR="8170" marT="81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5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4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3384881"/>
                  </a:ext>
                </a:extLst>
              </a:tr>
              <a:tr h="16339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D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klad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D.88137</a:t>
                      </a:r>
                    </a:p>
                  </a:txBody>
                  <a:tcPr marL="8170" marR="8170" marT="817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5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2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1</a:t>
                      </a:r>
                    </a:p>
                  </a:txBody>
                  <a:tcPr marL="8170" marR="8170" marT="81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4891270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B3C8A945-6C03-C79E-00AD-10C13F6B89CF}"/>
              </a:ext>
            </a:extLst>
          </p:cNvPr>
          <p:cNvSpPr txBox="1"/>
          <p:nvPr/>
        </p:nvSpPr>
        <p:spPr>
          <a:xfrm>
            <a:off x="1280736" y="4405623"/>
            <a:ext cx="37112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Source of fat: Soybean Oil in CD and Milkfat in WD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62687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C25DC659-ECEC-80BC-C8D6-61EF5931911A}"/>
              </a:ext>
            </a:extLst>
          </p:cNvPr>
          <p:cNvSpPr txBox="1"/>
          <p:nvPr/>
        </p:nvSpPr>
        <p:spPr>
          <a:xfrm>
            <a:off x="981448" y="1642189"/>
            <a:ext cx="1539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97B2ECF-0873-71DC-75C3-03A51AE6377E}"/>
              </a:ext>
            </a:extLst>
          </p:cNvPr>
          <p:cNvSpPr txBox="1"/>
          <p:nvPr/>
        </p:nvSpPr>
        <p:spPr>
          <a:xfrm>
            <a:off x="3545221" y="1642189"/>
            <a:ext cx="15393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67C5188-FCDF-64A3-6368-85F45E6F84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0355126"/>
              </p:ext>
            </p:extLst>
          </p:nvPr>
        </p:nvGraphicFramePr>
        <p:xfrm>
          <a:off x="996950" y="1945640"/>
          <a:ext cx="2698750" cy="2136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name="Prism 10" r:id="rId4" imgW="4117157" imgH="3079832" progId="Prism10.Document">
                  <p:embed/>
                </p:oleObj>
              </mc:Choice>
              <mc:Fallback>
                <p:oleObj name="Prism 10" r:id="rId4" imgW="4117157" imgH="3079832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867C5188-FCDF-64A3-6368-85F45E6F84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96950" y="1945640"/>
                        <a:ext cx="2698750" cy="2136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D21DABD3-40BA-B153-20E2-5EB2CA3A7E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8417603"/>
              </p:ext>
            </p:extLst>
          </p:nvPr>
        </p:nvGraphicFramePr>
        <p:xfrm>
          <a:off x="3551238" y="1931352"/>
          <a:ext cx="2698750" cy="2151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9" name="Prism 10" r:id="rId6" imgW="4117157" imgH="3099629" progId="Prism10.Document">
                  <p:embed/>
                </p:oleObj>
              </mc:Choice>
              <mc:Fallback>
                <p:oleObj name="Prism 10" r:id="rId6" imgW="4117157" imgH="3099629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D21DABD3-40BA-B153-20E2-5EB2CA3A7E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51238" y="1931352"/>
                        <a:ext cx="2698750" cy="2151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C7D574C3-172E-57B3-C377-CAA6A67145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7683495"/>
              </p:ext>
            </p:extLst>
          </p:nvPr>
        </p:nvGraphicFramePr>
        <p:xfrm>
          <a:off x="995363" y="6070600"/>
          <a:ext cx="2698750" cy="2138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10" r:id="rId8" imgW="4117157" imgH="3079832" progId="Prism10.Document">
                  <p:embed/>
                </p:oleObj>
              </mc:Choice>
              <mc:Fallback>
                <p:oleObj name="Prism 10" r:id="rId8" imgW="4117157" imgH="3079832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C7D574C3-172E-57B3-C377-CAA6A67145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95363" y="6070600"/>
                        <a:ext cx="2698750" cy="2138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742ECFEF-DA25-C9FF-9787-A1E01FE753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2420975"/>
              </p:ext>
            </p:extLst>
          </p:nvPr>
        </p:nvGraphicFramePr>
        <p:xfrm>
          <a:off x="3551238" y="6051550"/>
          <a:ext cx="2698750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1" name="Prism 10" r:id="rId10" imgW="4117157" imgH="3135986" progId="Prism10.Document">
                  <p:embed/>
                </p:oleObj>
              </mc:Choice>
              <mc:Fallback>
                <p:oleObj name="Prism 10" r:id="rId10" imgW="4117157" imgH="3135986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742ECFEF-DA25-C9FF-9787-A1E01FE753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551238" y="6051550"/>
                        <a:ext cx="2698750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BEAB4919-A124-6B56-C774-AD8FC99617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8385643"/>
              </p:ext>
            </p:extLst>
          </p:nvPr>
        </p:nvGraphicFramePr>
        <p:xfrm>
          <a:off x="995363" y="8096250"/>
          <a:ext cx="2700337" cy="2170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name="Prism 10" r:id="rId12" imgW="4117157" imgH="3125547" progId="Prism10.Document">
                  <p:embed/>
                </p:oleObj>
              </mc:Choice>
              <mc:Fallback>
                <p:oleObj name="Prism 10" r:id="rId12" imgW="4117157" imgH="3125547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BEAB4919-A124-6B56-C774-AD8FC996176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995363" y="8096250"/>
                        <a:ext cx="2700337" cy="2170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9AD345B5-04D4-939D-CD57-EAE9FDE68B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4602297"/>
              </p:ext>
            </p:extLst>
          </p:nvPr>
        </p:nvGraphicFramePr>
        <p:xfrm>
          <a:off x="3551238" y="8076883"/>
          <a:ext cx="2698750" cy="217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3" name="Prism 10" r:id="rId14" imgW="4117157" imgH="3135986" progId="Prism10.Document">
                  <p:embed/>
                </p:oleObj>
              </mc:Choice>
              <mc:Fallback>
                <p:oleObj name="Prism 10" r:id="rId14" imgW="4117157" imgH="3135986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9AD345B5-04D4-939D-CD57-EAE9FDE68B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51238" y="8076883"/>
                        <a:ext cx="2698750" cy="217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61176ACF-6C9C-7CD8-F3B9-272D128224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4423205"/>
              </p:ext>
            </p:extLst>
          </p:nvPr>
        </p:nvGraphicFramePr>
        <p:xfrm>
          <a:off x="996950" y="3979863"/>
          <a:ext cx="2698750" cy="2173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Prism 10" r:id="rId16" imgW="4117157" imgH="3135986" progId="Prism10.Document">
                  <p:embed/>
                </p:oleObj>
              </mc:Choice>
              <mc:Fallback>
                <p:oleObj name="Prism 10" r:id="rId16" imgW="4117157" imgH="3135986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61176ACF-6C9C-7CD8-F3B9-272D128224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996950" y="3979863"/>
                        <a:ext cx="2698750" cy="2173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FD876207-8C12-E16E-5111-AF1445335A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2846216"/>
              </p:ext>
            </p:extLst>
          </p:nvPr>
        </p:nvGraphicFramePr>
        <p:xfrm>
          <a:off x="3551238" y="4010025"/>
          <a:ext cx="2698750" cy="2112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5" name="Prism 10" r:id="rId18" imgW="4117157" imgH="3043116" progId="Prism10.Document">
                  <p:embed/>
                </p:oleObj>
              </mc:Choice>
              <mc:Fallback>
                <p:oleObj name="Prism 10" r:id="rId18" imgW="4117157" imgH="3043116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FD876207-8C12-E16E-5111-AF1445335A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551238" y="4010025"/>
                        <a:ext cx="2698750" cy="2112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67130B01-E052-DC5B-D613-1333D8853918}"/>
              </a:ext>
            </a:extLst>
          </p:cNvPr>
          <p:cNvSpPr txBox="1"/>
          <p:nvPr/>
        </p:nvSpPr>
        <p:spPr>
          <a:xfrm>
            <a:off x="981448" y="10533042"/>
            <a:ext cx="500263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2: Body composition of control and MO mice.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lang="en-US" sz="14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880AA41-3F5B-4A6A-89FA-A25BD5ED0E60}"/>
              </a:ext>
            </a:extLst>
          </p:cNvPr>
          <p:cNvSpPr/>
          <p:nvPr/>
        </p:nvSpPr>
        <p:spPr>
          <a:xfrm>
            <a:off x="988249" y="1954212"/>
            <a:ext cx="2440751" cy="8245283"/>
          </a:xfrm>
          <a:prstGeom prst="rect">
            <a:avLst/>
          </a:prstGeom>
          <a:noFill/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1pPr>
            <a:lvl2pPr marL="4572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2pPr>
            <a:lvl3pPr marL="9144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3pPr>
            <a:lvl4pPr marL="13716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4pPr>
            <a:lvl5pPr marL="18288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5pPr>
            <a:lvl6pPr marL="22860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6pPr>
            <a:lvl7pPr marL="27432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7pPr>
            <a:lvl8pPr marL="32004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8pPr>
            <a:lvl9pPr marL="36576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9pPr>
          </a:lstStyle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B338E90-D4FB-4326-B1E6-28C7B154B698}"/>
              </a:ext>
            </a:extLst>
          </p:cNvPr>
          <p:cNvSpPr/>
          <p:nvPr/>
        </p:nvSpPr>
        <p:spPr>
          <a:xfrm>
            <a:off x="3543332" y="1954721"/>
            <a:ext cx="2440751" cy="8245283"/>
          </a:xfrm>
          <a:prstGeom prst="rect">
            <a:avLst/>
          </a:prstGeom>
          <a:noFill/>
          <a:ln w="381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1pPr>
            <a:lvl2pPr marL="4572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2pPr>
            <a:lvl3pPr marL="9144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3pPr>
            <a:lvl4pPr marL="13716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4pPr>
            <a:lvl5pPr marL="18288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5pPr>
            <a:lvl6pPr marL="22860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6pPr>
            <a:lvl7pPr marL="27432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7pPr>
            <a:lvl8pPr marL="32004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8pPr>
            <a:lvl9pPr marL="3657600" algn="l" defTabSz="457200" rtl="0" eaLnBrk="1" latinLnBrk="0" hangingPunct="1">
              <a:defRPr sz="1800" kern="1200">
                <a:solidFill>
                  <a:sysClr val="window" lastClr="FFFFFF"/>
                </a:solidFill>
                <a:latin typeface="Calibri" panose="020F0502020204030204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2820549" y="10324869"/>
            <a:ext cx="247973" cy="138329"/>
          </a:xfrm>
          <a:prstGeom prst="rect">
            <a:avLst/>
          </a:prstGeom>
          <a:solidFill>
            <a:srgbClr val="0000FF"/>
          </a:solidFill>
          <a:ln>
            <a:solidFill>
              <a:srgbClr val="000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Rectangle 25"/>
          <p:cNvSpPr/>
          <p:nvPr/>
        </p:nvSpPr>
        <p:spPr>
          <a:xfrm>
            <a:off x="3642992" y="10324869"/>
            <a:ext cx="247973" cy="138329"/>
          </a:xfrm>
          <a:prstGeom prst="rect">
            <a:avLst/>
          </a:prstGeom>
          <a:solidFill>
            <a:srgbClr val="FF0A0A"/>
          </a:solidFill>
          <a:ln>
            <a:solidFill>
              <a:srgbClr val="A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068522" y="10255534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890965" y="10255534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</a:p>
        </p:txBody>
      </p:sp>
    </p:spTree>
    <p:extLst>
      <p:ext uri="{BB962C8B-B14F-4D97-AF65-F5344CB8AC3E}">
        <p14:creationId xmlns:p14="http://schemas.microsoft.com/office/powerpoint/2010/main" val="33100834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A141B6A-8874-4A10-AE53-17A186A4A8D8}"/>
              </a:ext>
            </a:extLst>
          </p:cNvPr>
          <p:cNvSpPr txBox="1"/>
          <p:nvPr/>
        </p:nvSpPr>
        <p:spPr>
          <a:xfrm>
            <a:off x="724733" y="2498535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T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CD0EC3-E809-4602-BD52-600497DD056A}"/>
              </a:ext>
            </a:extLst>
          </p:cNvPr>
          <p:cNvSpPr txBox="1"/>
          <p:nvPr/>
        </p:nvSpPr>
        <p:spPr>
          <a:xfrm>
            <a:off x="684349" y="1674440"/>
            <a:ext cx="8899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: Male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2CF685D-93B7-4827-B6F2-34B49298B08B}"/>
              </a:ext>
            </a:extLst>
          </p:cNvPr>
          <p:cNvSpPr txBox="1"/>
          <p:nvPr/>
        </p:nvSpPr>
        <p:spPr>
          <a:xfrm>
            <a:off x="2175665" y="2175546"/>
            <a:ext cx="594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M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D551C26-62D9-4E83-88BE-EB6CBFC48F67}"/>
              </a:ext>
            </a:extLst>
          </p:cNvPr>
          <p:cNvSpPr txBox="1"/>
          <p:nvPr/>
        </p:nvSpPr>
        <p:spPr>
          <a:xfrm>
            <a:off x="724733" y="3062505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M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355A88-5B73-4C02-B654-A935BAAFBD2D}"/>
              </a:ext>
            </a:extLst>
          </p:cNvPr>
          <p:cNvSpPr txBox="1"/>
          <p:nvPr/>
        </p:nvSpPr>
        <p:spPr>
          <a:xfrm>
            <a:off x="1285160" y="2162434"/>
            <a:ext cx="4142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PS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2808C11-3A2E-42A7-B4E8-66E048780DB7}"/>
              </a:ext>
            </a:extLst>
          </p:cNvPr>
          <p:cNvSpPr txBox="1"/>
          <p:nvPr/>
        </p:nvSpPr>
        <p:spPr>
          <a:xfrm>
            <a:off x="3496771" y="2498535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T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57C4CE4-718C-441C-9FCD-3588F9F4EC2D}"/>
              </a:ext>
            </a:extLst>
          </p:cNvPr>
          <p:cNvSpPr txBox="1"/>
          <p:nvPr/>
        </p:nvSpPr>
        <p:spPr>
          <a:xfrm>
            <a:off x="3496771" y="3062505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MO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39FC0DA-35F9-4B7F-8E96-624DB1604329}"/>
              </a:ext>
            </a:extLst>
          </p:cNvPr>
          <p:cNvSpPr txBox="1"/>
          <p:nvPr/>
        </p:nvSpPr>
        <p:spPr>
          <a:xfrm>
            <a:off x="1464932" y="1987408"/>
            <a:ext cx="878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7D7E8BD-ED6A-407A-A308-C69AD439890A}"/>
              </a:ext>
            </a:extLst>
          </p:cNvPr>
          <p:cNvSpPr txBox="1"/>
          <p:nvPr/>
        </p:nvSpPr>
        <p:spPr>
          <a:xfrm>
            <a:off x="4908315" y="2144587"/>
            <a:ext cx="594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M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9997155-1CF6-4371-B15B-8324015764A1}"/>
              </a:ext>
            </a:extLst>
          </p:cNvPr>
          <p:cNvSpPr txBox="1"/>
          <p:nvPr/>
        </p:nvSpPr>
        <p:spPr>
          <a:xfrm>
            <a:off x="4049731" y="2131475"/>
            <a:ext cx="4142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PS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8BA159F-CD59-4966-8C27-5B2F13C5E382}"/>
              </a:ext>
            </a:extLst>
          </p:cNvPr>
          <p:cNvSpPr txBox="1"/>
          <p:nvPr/>
        </p:nvSpPr>
        <p:spPr>
          <a:xfrm>
            <a:off x="3437514" y="1689844"/>
            <a:ext cx="1119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: Female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6753EA7-57E0-407B-8B46-5FD46B124DA7}"/>
              </a:ext>
            </a:extLst>
          </p:cNvPr>
          <p:cNvSpPr txBox="1"/>
          <p:nvPr/>
        </p:nvSpPr>
        <p:spPr>
          <a:xfrm>
            <a:off x="1285160" y="3556851"/>
            <a:ext cx="4142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PSR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57FAD4A-A248-4EC2-BC59-77759FBB0C55}"/>
              </a:ext>
            </a:extLst>
          </p:cNvPr>
          <p:cNvSpPr txBox="1"/>
          <p:nvPr/>
        </p:nvSpPr>
        <p:spPr>
          <a:xfrm>
            <a:off x="2175665" y="3566585"/>
            <a:ext cx="594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MT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1ECDCFD-B865-4283-8CA4-BC37113616BC}"/>
              </a:ext>
            </a:extLst>
          </p:cNvPr>
          <p:cNvSpPr txBox="1"/>
          <p:nvPr/>
        </p:nvSpPr>
        <p:spPr>
          <a:xfrm>
            <a:off x="1285160" y="5260022"/>
            <a:ext cx="4142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PSR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2C4B369-BB87-42E9-9A85-62E7D8E51F48}"/>
              </a:ext>
            </a:extLst>
          </p:cNvPr>
          <p:cNvSpPr txBox="1"/>
          <p:nvPr/>
        </p:nvSpPr>
        <p:spPr>
          <a:xfrm>
            <a:off x="2175665" y="5269236"/>
            <a:ext cx="594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MT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92984EA-20A8-4BCE-AA08-58B10EEDEC76}"/>
              </a:ext>
            </a:extLst>
          </p:cNvPr>
          <p:cNvSpPr txBox="1"/>
          <p:nvPr/>
        </p:nvSpPr>
        <p:spPr>
          <a:xfrm>
            <a:off x="860127" y="6858396"/>
            <a:ext cx="49813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Whole section fibrosis images for heart, kidney, and liver.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6C69B46F-4CE9-410F-BEB9-F9A24FFEA296}"/>
              </a:ext>
            </a:extLst>
          </p:cNvPr>
          <p:cNvSpPr txBox="1"/>
          <p:nvPr/>
        </p:nvSpPr>
        <p:spPr>
          <a:xfrm>
            <a:off x="3496771" y="3899593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TL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A243490-D755-4039-9D13-DD9963500D42}"/>
              </a:ext>
            </a:extLst>
          </p:cNvPr>
          <p:cNvSpPr txBox="1"/>
          <p:nvPr/>
        </p:nvSpPr>
        <p:spPr>
          <a:xfrm>
            <a:off x="3496771" y="4521731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MO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EB3D661-56F9-4B9E-BF95-E85286BB8AB3}"/>
              </a:ext>
            </a:extLst>
          </p:cNvPr>
          <p:cNvSpPr txBox="1"/>
          <p:nvPr/>
        </p:nvSpPr>
        <p:spPr>
          <a:xfrm>
            <a:off x="4908315" y="3586514"/>
            <a:ext cx="594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MT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26E0F17-1CBB-4ADB-8136-52CF5D452AC5}"/>
              </a:ext>
            </a:extLst>
          </p:cNvPr>
          <p:cNvSpPr txBox="1"/>
          <p:nvPr/>
        </p:nvSpPr>
        <p:spPr>
          <a:xfrm>
            <a:off x="4049731" y="3573402"/>
            <a:ext cx="4142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PSR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4C35770-CD24-402F-866E-FA31E617C0D1}"/>
              </a:ext>
            </a:extLst>
          </p:cNvPr>
          <p:cNvSpPr txBox="1"/>
          <p:nvPr/>
        </p:nvSpPr>
        <p:spPr>
          <a:xfrm>
            <a:off x="3496771" y="5598322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TL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A9CB7E1C-C5CF-4168-9102-CC53E01FAFF5}"/>
              </a:ext>
            </a:extLst>
          </p:cNvPr>
          <p:cNvSpPr txBox="1"/>
          <p:nvPr/>
        </p:nvSpPr>
        <p:spPr>
          <a:xfrm>
            <a:off x="3496771" y="6173936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MO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385CABD5-D95E-4023-8BB6-2F169499CC1C}"/>
              </a:ext>
            </a:extLst>
          </p:cNvPr>
          <p:cNvSpPr txBox="1"/>
          <p:nvPr/>
        </p:nvSpPr>
        <p:spPr>
          <a:xfrm>
            <a:off x="4908315" y="5198394"/>
            <a:ext cx="594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MT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24AD1A86-E3C2-4087-954E-373A99C24C1A}"/>
              </a:ext>
            </a:extLst>
          </p:cNvPr>
          <p:cNvSpPr txBox="1"/>
          <p:nvPr/>
        </p:nvSpPr>
        <p:spPr>
          <a:xfrm>
            <a:off x="4049731" y="5198394"/>
            <a:ext cx="4142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PSR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6AC80E9E-DBE0-4461-99AC-F0D0FCA9702B}"/>
              </a:ext>
            </a:extLst>
          </p:cNvPr>
          <p:cNvSpPr txBox="1"/>
          <p:nvPr/>
        </p:nvSpPr>
        <p:spPr>
          <a:xfrm>
            <a:off x="724733" y="5598322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TL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75EF7387-D275-45F3-9F9A-3439D7D9B6AA}"/>
              </a:ext>
            </a:extLst>
          </p:cNvPr>
          <p:cNvSpPr txBox="1"/>
          <p:nvPr/>
        </p:nvSpPr>
        <p:spPr>
          <a:xfrm>
            <a:off x="724733" y="6173936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MO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226C666C-47CC-4CF4-854E-BFB359664859}"/>
              </a:ext>
            </a:extLst>
          </p:cNvPr>
          <p:cNvSpPr txBox="1"/>
          <p:nvPr/>
        </p:nvSpPr>
        <p:spPr>
          <a:xfrm>
            <a:off x="724733" y="3899593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TL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5576D26-22F4-40E8-9D4A-75240D5830EF}"/>
              </a:ext>
            </a:extLst>
          </p:cNvPr>
          <p:cNvSpPr txBox="1"/>
          <p:nvPr/>
        </p:nvSpPr>
        <p:spPr>
          <a:xfrm>
            <a:off x="724733" y="4521731"/>
            <a:ext cx="504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MO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90FF8A6-7BAA-41DA-AF31-384DABC9F1A9}"/>
              </a:ext>
            </a:extLst>
          </p:cNvPr>
          <p:cNvSpPr txBox="1"/>
          <p:nvPr/>
        </p:nvSpPr>
        <p:spPr>
          <a:xfrm>
            <a:off x="1473373" y="3443573"/>
            <a:ext cx="878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05DA6F7F-7CD3-49CF-87A5-2687739BF7FF}"/>
              </a:ext>
            </a:extLst>
          </p:cNvPr>
          <p:cNvSpPr txBox="1"/>
          <p:nvPr/>
        </p:nvSpPr>
        <p:spPr>
          <a:xfrm>
            <a:off x="1461640" y="5073976"/>
            <a:ext cx="878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880AA41-3F5B-4A6A-89FA-A25BD5ED0E60}"/>
              </a:ext>
            </a:extLst>
          </p:cNvPr>
          <p:cNvSpPr/>
          <p:nvPr/>
        </p:nvSpPr>
        <p:spPr>
          <a:xfrm>
            <a:off x="771336" y="1980078"/>
            <a:ext cx="2262498" cy="475042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1D78C60B-EC34-4924-BA83-5FF67D7A4C46}"/>
              </a:ext>
            </a:extLst>
          </p:cNvPr>
          <p:cNvSpPr/>
          <p:nvPr/>
        </p:nvSpPr>
        <p:spPr>
          <a:xfrm>
            <a:off x="3509085" y="1999439"/>
            <a:ext cx="2216202" cy="472902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FD1F13A-C83D-4DCE-916F-8A2D89D7F811}"/>
              </a:ext>
            </a:extLst>
          </p:cNvPr>
          <p:cNvSpPr txBox="1"/>
          <p:nvPr/>
        </p:nvSpPr>
        <p:spPr>
          <a:xfrm>
            <a:off x="4254137" y="5066422"/>
            <a:ext cx="878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21650A3-A058-71F6-AF18-60045BC7A2DB}"/>
              </a:ext>
            </a:extLst>
          </p:cNvPr>
          <p:cNvSpPr txBox="1"/>
          <p:nvPr/>
        </p:nvSpPr>
        <p:spPr>
          <a:xfrm>
            <a:off x="4253775" y="3441439"/>
            <a:ext cx="878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FF2C55DB-AA04-ECD7-F98B-9159D10C8AFA}"/>
              </a:ext>
            </a:extLst>
          </p:cNvPr>
          <p:cNvSpPr txBox="1"/>
          <p:nvPr/>
        </p:nvSpPr>
        <p:spPr>
          <a:xfrm>
            <a:off x="4221542" y="1983820"/>
            <a:ext cx="878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</p:txBody>
      </p:sp>
      <p:pic>
        <p:nvPicPr>
          <p:cNvPr id="90" name="Picture 89">
            <a:extLst>
              <a:ext uri="{FF2B5EF4-FFF2-40B4-BE49-F238E27FC236}">
                <a16:creationId xmlns:a16="http://schemas.microsoft.com/office/drawing/2014/main" id="{7869A997-1F24-2491-DBF5-5D47BC00D7D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4427" t="3109" r="50605" b="47236"/>
          <a:stretch>
            <a:fillRect/>
          </a:stretch>
        </p:blipFill>
        <p:spPr>
          <a:xfrm rot="16200000">
            <a:off x="4020438" y="2197570"/>
            <a:ext cx="472849" cy="817377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CC09080F-CD5D-C5FA-508B-65B53BA4257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6968" t="11322" r="23779" b="43627"/>
          <a:stretch>
            <a:fillRect/>
          </a:stretch>
        </p:blipFill>
        <p:spPr>
          <a:xfrm rot="16200000">
            <a:off x="4032993" y="3551979"/>
            <a:ext cx="447736" cy="910675"/>
          </a:xfrm>
          <a:prstGeom prst="rect">
            <a:avLst/>
          </a:prstGeom>
        </p:spPr>
      </p:pic>
      <p:pic>
        <p:nvPicPr>
          <p:cNvPr id="103" name="Picture 102">
            <a:extLst>
              <a:ext uri="{FF2B5EF4-FFF2-40B4-BE49-F238E27FC236}">
                <a16:creationId xmlns:a16="http://schemas.microsoft.com/office/drawing/2014/main" id="{9EA5CE84-6DBF-3680-9438-B2214C00B61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3858" t="58238" r="52796" b="471"/>
          <a:stretch>
            <a:fillRect/>
          </a:stretch>
        </p:blipFill>
        <p:spPr>
          <a:xfrm rot="5400000">
            <a:off x="4010217" y="5326891"/>
            <a:ext cx="493288" cy="758309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AEFF0388-E7A2-1186-6639-1400C47CE4C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8541" r="73450" b="45920"/>
          <a:stretch>
            <a:fillRect/>
          </a:stretch>
        </p:blipFill>
        <p:spPr>
          <a:xfrm>
            <a:off x="3856921" y="5984954"/>
            <a:ext cx="799883" cy="593408"/>
          </a:xfrm>
          <a:prstGeom prst="rect">
            <a:avLst/>
          </a:prstGeom>
        </p:spPr>
      </p:pic>
      <p:pic>
        <p:nvPicPr>
          <p:cNvPr id="105" name="Picture 104">
            <a:extLst>
              <a:ext uri="{FF2B5EF4-FFF2-40B4-BE49-F238E27FC236}">
                <a16:creationId xmlns:a16="http://schemas.microsoft.com/office/drawing/2014/main" id="{076143B8-8B48-1A2D-96FB-CBC1BAF35C2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1021" t="586" r="12429" b="73715"/>
          <a:stretch>
            <a:fillRect/>
          </a:stretch>
        </p:blipFill>
        <p:spPr>
          <a:xfrm>
            <a:off x="3849406" y="4325272"/>
            <a:ext cx="814913" cy="608365"/>
          </a:xfrm>
          <a:prstGeom prst="rect">
            <a:avLst/>
          </a:prstGeom>
        </p:spPr>
      </p:pic>
      <p:pic>
        <p:nvPicPr>
          <p:cNvPr id="110" name="Picture 109">
            <a:extLst>
              <a:ext uri="{FF2B5EF4-FFF2-40B4-BE49-F238E27FC236}">
                <a16:creationId xmlns:a16="http://schemas.microsoft.com/office/drawing/2014/main" id="{FEB957A8-991C-970F-8327-53AD2B583E6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081" t="2207" r="46186" b="69285"/>
          <a:stretch>
            <a:fillRect/>
          </a:stretch>
        </p:blipFill>
        <p:spPr>
          <a:xfrm>
            <a:off x="3804596" y="2947927"/>
            <a:ext cx="904530" cy="444603"/>
          </a:xfrm>
          <a:prstGeom prst="rect">
            <a:avLst/>
          </a:prstGeom>
        </p:spPr>
      </p:pic>
      <p:pic>
        <p:nvPicPr>
          <p:cNvPr id="111" name="Picture 110">
            <a:extLst>
              <a:ext uri="{FF2B5EF4-FFF2-40B4-BE49-F238E27FC236}">
                <a16:creationId xmlns:a16="http://schemas.microsoft.com/office/drawing/2014/main" id="{FF13996D-67F3-39F2-68E4-45494CEFCAF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0174" t="57718" r="57372" b="3537"/>
          <a:stretch>
            <a:fillRect/>
          </a:stretch>
        </p:blipFill>
        <p:spPr>
          <a:xfrm rot="5400000">
            <a:off x="4938017" y="5314723"/>
            <a:ext cx="535492" cy="782642"/>
          </a:xfrm>
          <a:prstGeom prst="rect">
            <a:avLst/>
          </a:prstGeom>
        </p:spPr>
      </p:pic>
      <p:pic>
        <p:nvPicPr>
          <p:cNvPr id="113" name="Picture 112">
            <a:extLst>
              <a:ext uri="{FF2B5EF4-FFF2-40B4-BE49-F238E27FC236}">
                <a16:creationId xmlns:a16="http://schemas.microsoft.com/office/drawing/2014/main" id="{C9B62D21-A2AA-5EB6-E64F-C2293877FF9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6254" t="13762" r="24747" b="43609"/>
          <a:stretch>
            <a:fillRect/>
          </a:stretch>
        </p:blipFill>
        <p:spPr>
          <a:xfrm rot="16200000">
            <a:off x="4966167" y="3551976"/>
            <a:ext cx="479192" cy="910678"/>
          </a:xfrm>
          <a:prstGeom prst="rect">
            <a:avLst/>
          </a:prstGeom>
        </p:spPr>
      </p:pic>
      <p:pic>
        <p:nvPicPr>
          <p:cNvPr id="114" name="Picture 113">
            <a:extLst>
              <a:ext uri="{FF2B5EF4-FFF2-40B4-BE49-F238E27FC236}">
                <a16:creationId xmlns:a16="http://schemas.microsoft.com/office/drawing/2014/main" id="{E91346E8-7E8F-6D2C-AA24-1A01A3AA14A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973" r="48927" b="48141"/>
          <a:stretch>
            <a:fillRect/>
          </a:stretch>
        </p:blipFill>
        <p:spPr>
          <a:xfrm rot="16200000">
            <a:off x="4926811" y="2136795"/>
            <a:ext cx="557907" cy="938927"/>
          </a:xfrm>
          <a:prstGeom prst="rect">
            <a:avLst/>
          </a:prstGeom>
        </p:spPr>
      </p:pic>
      <p:pic>
        <p:nvPicPr>
          <p:cNvPr id="115" name="Picture 114">
            <a:extLst>
              <a:ext uri="{FF2B5EF4-FFF2-40B4-BE49-F238E27FC236}">
                <a16:creationId xmlns:a16="http://schemas.microsoft.com/office/drawing/2014/main" id="{9F166680-7D10-244A-0EF1-F865F0FFC8F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2022" t="1" r="43972" b="69821"/>
          <a:stretch>
            <a:fillRect/>
          </a:stretch>
        </p:blipFill>
        <p:spPr>
          <a:xfrm>
            <a:off x="4753498" y="2911196"/>
            <a:ext cx="904530" cy="518065"/>
          </a:xfrm>
          <a:prstGeom prst="rect">
            <a:avLst/>
          </a:prstGeom>
        </p:spPr>
      </p:pic>
      <p:pic>
        <p:nvPicPr>
          <p:cNvPr id="116" name="Picture 115">
            <a:extLst>
              <a:ext uri="{FF2B5EF4-FFF2-40B4-BE49-F238E27FC236}">
                <a16:creationId xmlns:a16="http://schemas.microsoft.com/office/drawing/2014/main" id="{F2B73C3F-C6EA-A316-1146-27348849C89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999" t="24491" r="74032" b="50915"/>
          <a:stretch>
            <a:fillRect/>
          </a:stretch>
        </p:blipFill>
        <p:spPr>
          <a:xfrm>
            <a:off x="4846370" y="5986009"/>
            <a:ext cx="718786" cy="591301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9A4892E9-A056-1031-087D-61EC7CC2BCF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4513" t="5956" r="9518" b="67092"/>
          <a:stretch>
            <a:fillRect/>
          </a:stretch>
        </p:blipFill>
        <p:spPr>
          <a:xfrm>
            <a:off x="4856276" y="4326508"/>
            <a:ext cx="698974" cy="605893"/>
          </a:xfrm>
          <a:prstGeom prst="rect">
            <a:avLst/>
          </a:prstGeom>
        </p:spPr>
      </p:pic>
      <p:pic>
        <p:nvPicPr>
          <p:cNvPr id="120" name="Picture 119">
            <a:extLst>
              <a:ext uri="{FF2B5EF4-FFF2-40B4-BE49-F238E27FC236}">
                <a16:creationId xmlns:a16="http://schemas.microsoft.com/office/drawing/2014/main" id="{2AD05CD5-F1CE-37AD-1F0E-67190A618711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738" t="5431" r="43731" b="68752"/>
          <a:stretch>
            <a:fillRect/>
          </a:stretch>
        </p:blipFill>
        <p:spPr>
          <a:xfrm>
            <a:off x="1013364" y="2359913"/>
            <a:ext cx="957852" cy="492691"/>
          </a:xfrm>
          <a:prstGeom prst="rect">
            <a:avLst/>
          </a:prstGeom>
        </p:spPr>
      </p:pic>
      <p:pic>
        <p:nvPicPr>
          <p:cNvPr id="127" name="Picture 126">
            <a:extLst>
              <a:ext uri="{FF2B5EF4-FFF2-40B4-BE49-F238E27FC236}">
                <a16:creationId xmlns:a16="http://schemas.microsoft.com/office/drawing/2014/main" id="{EED27544-28F0-E81F-4C95-8605EFD26FB6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5201" t="30409" r="46847" b="55155"/>
          <a:stretch>
            <a:fillRect/>
          </a:stretch>
        </p:blipFill>
        <p:spPr>
          <a:xfrm>
            <a:off x="1037746" y="3816010"/>
            <a:ext cx="909091" cy="382610"/>
          </a:xfrm>
          <a:prstGeom prst="rect">
            <a:avLst/>
          </a:prstGeom>
        </p:spPr>
      </p:pic>
      <p:pic>
        <p:nvPicPr>
          <p:cNvPr id="1024" name="Picture 1023">
            <a:extLst>
              <a:ext uri="{FF2B5EF4-FFF2-40B4-BE49-F238E27FC236}">
                <a16:creationId xmlns:a16="http://schemas.microsoft.com/office/drawing/2014/main" id="{C2638A31-111E-79AC-E26E-A21C00EE9227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1557" t="45177" r="53384" b="33748"/>
          <a:stretch>
            <a:fillRect/>
          </a:stretch>
        </p:blipFill>
        <p:spPr>
          <a:xfrm rot="10800000">
            <a:off x="1083017" y="5433841"/>
            <a:ext cx="818546" cy="544406"/>
          </a:xfrm>
          <a:prstGeom prst="rect">
            <a:avLst/>
          </a:prstGeom>
        </p:spPr>
      </p:pic>
      <p:pic>
        <p:nvPicPr>
          <p:cNvPr id="1025" name="Picture 1024">
            <a:extLst>
              <a:ext uri="{FF2B5EF4-FFF2-40B4-BE49-F238E27FC236}">
                <a16:creationId xmlns:a16="http://schemas.microsoft.com/office/drawing/2014/main" id="{44963A73-7817-DAB0-FD3C-CC0AF5D9B916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48847" t="3820" r="27539" b="47856"/>
          <a:stretch>
            <a:fillRect/>
          </a:stretch>
        </p:blipFill>
        <p:spPr>
          <a:xfrm rot="5400000">
            <a:off x="1219939" y="2710649"/>
            <a:ext cx="544705" cy="919157"/>
          </a:xfrm>
          <a:prstGeom prst="rect">
            <a:avLst/>
          </a:prstGeom>
        </p:spPr>
      </p:pic>
      <p:pic>
        <p:nvPicPr>
          <p:cNvPr id="1027" name="Picture 1026">
            <a:extLst>
              <a:ext uri="{FF2B5EF4-FFF2-40B4-BE49-F238E27FC236}">
                <a16:creationId xmlns:a16="http://schemas.microsoft.com/office/drawing/2014/main" id="{7771819E-C6A8-EAF2-E8BE-63E2408CA9DC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76851" b="62181"/>
          <a:stretch>
            <a:fillRect/>
          </a:stretch>
        </p:blipFill>
        <p:spPr>
          <a:xfrm rot="16200000">
            <a:off x="1168560" y="4205652"/>
            <a:ext cx="629180" cy="847602"/>
          </a:xfrm>
          <a:prstGeom prst="rect">
            <a:avLst/>
          </a:prstGeom>
        </p:spPr>
      </p:pic>
      <p:pic>
        <p:nvPicPr>
          <p:cNvPr id="1028" name="Picture 1027">
            <a:extLst>
              <a:ext uri="{FF2B5EF4-FFF2-40B4-BE49-F238E27FC236}">
                <a16:creationId xmlns:a16="http://schemas.microsoft.com/office/drawing/2014/main" id="{8313C044-F9AE-2F62-E028-8AD1DBFBECD9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9832" t="12265" r="55218" b="46106"/>
          <a:stretch>
            <a:fillRect/>
          </a:stretch>
        </p:blipFill>
        <p:spPr>
          <a:xfrm rot="16200000">
            <a:off x="1200429" y="5880114"/>
            <a:ext cx="583725" cy="803091"/>
          </a:xfrm>
          <a:prstGeom prst="rect">
            <a:avLst/>
          </a:prstGeom>
        </p:spPr>
      </p:pic>
      <p:pic>
        <p:nvPicPr>
          <p:cNvPr id="1029" name="Picture 1028">
            <a:extLst>
              <a:ext uri="{FF2B5EF4-FFF2-40B4-BE49-F238E27FC236}">
                <a16:creationId xmlns:a16="http://schemas.microsoft.com/office/drawing/2014/main" id="{A7AFA80D-CE74-6C7C-2D00-B6E4A1919854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2880" t="25973" r="49200" b="58370"/>
          <a:stretch>
            <a:fillRect/>
          </a:stretch>
        </p:blipFill>
        <p:spPr>
          <a:xfrm>
            <a:off x="2040838" y="3800433"/>
            <a:ext cx="864550" cy="413764"/>
          </a:xfrm>
          <a:prstGeom prst="rect">
            <a:avLst/>
          </a:prstGeom>
        </p:spPr>
      </p:pic>
      <p:pic>
        <p:nvPicPr>
          <p:cNvPr id="1030" name="Picture 1029">
            <a:extLst>
              <a:ext uri="{FF2B5EF4-FFF2-40B4-BE49-F238E27FC236}">
                <a16:creationId xmlns:a16="http://schemas.microsoft.com/office/drawing/2014/main" id="{74D461F3-4947-7BD1-7889-306F760D0F9E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819" t="40242" r="62152" b="40512"/>
          <a:stretch>
            <a:fillRect/>
          </a:stretch>
        </p:blipFill>
        <p:spPr>
          <a:xfrm rot="10800000">
            <a:off x="2029767" y="5431539"/>
            <a:ext cx="886695" cy="549010"/>
          </a:xfrm>
          <a:prstGeom prst="rect">
            <a:avLst/>
          </a:prstGeom>
        </p:spPr>
      </p:pic>
      <p:pic>
        <p:nvPicPr>
          <p:cNvPr id="1031" name="Picture 1030">
            <a:extLst>
              <a:ext uri="{FF2B5EF4-FFF2-40B4-BE49-F238E27FC236}">
                <a16:creationId xmlns:a16="http://schemas.microsoft.com/office/drawing/2014/main" id="{0A76421C-AADA-DB97-5B27-8A2732928891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3902" r="37995" b="73376"/>
          <a:stretch>
            <a:fillRect/>
          </a:stretch>
        </p:blipFill>
        <p:spPr>
          <a:xfrm>
            <a:off x="1994189" y="2351892"/>
            <a:ext cx="957851" cy="508733"/>
          </a:xfrm>
          <a:prstGeom prst="rect">
            <a:avLst/>
          </a:prstGeom>
        </p:spPr>
      </p:pic>
      <p:pic>
        <p:nvPicPr>
          <p:cNvPr id="1032" name="Picture 1031">
            <a:extLst>
              <a:ext uri="{FF2B5EF4-FFF2-40B4-BE49-F238E27FC236}">
                <a16:creationId xmlns:a16="http://schemas.microsoft.com/office/drawing/2014/main" id="{9C0AF2DA-A99E-4F47-4211-D1B3F72FE55C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49931" t="3376" r="28443" b="51209"/>
          <a:stretch>
            <a:fillRect/>
          </a:stretch>
        </p:blipFill>
        <p:spPr>
          <a:xfrm rot="5400000">
            <a:off x="2202019" y="2714297"/>
            <a:ext cx="542188" cy="911860"/>
          </a:xfrm>
          <a:prstGeom prst="rect">
            <a:avLst/>
          </a:prstGeom>
        </p:spPr>
      </p:pic>
      <p:pic>
        <p:nvPicPr>
          <p:cNvPr id="1033" name="Picture 1032">
            <a:extLst>
              <a:ext uri="{FF2B5EF4-FFF2-40B4-BE49-F238E27FC236}">
                <a16:creationId xmlns:a16="http://schemas.microsoft.com/office/drawing/2014/main" id="{CF84A064-758D-B67D-60A5-9C476F4608A5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75840" b="63464"/>
          <a:stretch>
            <a:fillRect/>
          </a:stretch>
        </p:blipFill>
        <p:spPr>
          <a:xfrm rot="16200000">
            <a:off x="2129135" y="4223933"/>
            <a:ext cx="669676" cy="811043"/>
          </a:xfrm>
          <a:prstGeom prst="rect">
            <a:avLst/>
          </a:prstGeom>
        </p:spPr>
      </p:pic>
      <p:pic>
        <p:nvPicPr>
          <p:cNvPr id="1034" name="Picture 1033">
            <a:extLst>
              <a:ext uri="{FF2B5EF4-FFF2-40B4-BE49-F238E27FC236}">
                <a16:creationId xmlns:a16="http://schemas.microsoft.com/office/drawing/2014/main" id="{BD5F5003-4914-39CF-BEAD-CADA76BCA520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21801" t="10308" r="55188" b="48536"/>
          <a:stretch>
            <a:fillRect/>
          </a:stretch>
        </p:blipFill>
        <p:spPr>
          <a:xfrm rot="16200000">
            <a:off x="2198608" y="5888462"/>
            <a:ext cx="549010" cy="786395"/>
          </a:xfrm>
          <a:prstGeom prst="rect">
            <a:avLst/>
          </a:prstGeom>
        </p:spPr>
      </p:pic>
      <p:sp>
        <p:nvSpPr>
          <p:cNvPr id="1035" name="Rectangle 1034">
            <a:extLst>
              <a:ext uri="{FF2B5EF4-FFF2-40B4-BE49-F238E27FC236}">
                <a16:creationId xmlns:a16="http://schemas.microsoft.com/office/drawing/2014/main" id="{DB7ABB05-B0F1-6542-C5D1-F99F79DD69F2}"/>
              </a:ext>
            </a:extLst>
          </p:cNvPr>
          <p:cNvSpPr/>
          <p:nvPr/>
        </p:nvSpPr>
        <p:spPr>
          <a:xfrm>
            <a:off x="3816764" y="4800747"/>
            <a:ext cx="355087" cy="1541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6" name="Rectangle 1035">
            <a:extLst>
              <a:ext uri="{FF2B5EF4-FFF2-40B4-BE49-F238E27FC236}">
                <a16:creationId xmlns:a16="http://schemas.microsoft.com/office/drawing/2014/main" id="{BA61B47D-710A-3875-9A45-B01809F8517F}"/>
              </a:ext>
            </a:extLst>
          </p:cNvPr>
          <p:cNvSpPr/>
          <p:nvPr/>
        </p:nvSpPr>
        <p:spPr>
          <a:xfrm>
            <a:off x="4850181" y="4780905"/>
            <a:ext cx="217843" cy="1541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7" name="Rectangle 1036">
            <a:extLst>
              <a:ext uri="{FF2B5EF4-FFF2-40B4-BE49-F238E27FC236}">
                <a16:creationId xmlns:a16="http://schemas.microsoft.com/office/drawing/2014/main" id="{86612AD0-F241-0F60-86F1-688B5351013F}"/>
              </a:ext>
            </a:extLst>
          </p:cNvPr>
          <p:cNvSpPr/>
          <p:nvPr/>
        </p:nvSpPr>
        <p:spPr>
          <a:xfrm>
            <a:off x="4862496" y="4810100"/>
            <a:ext cx="217843" cy="1541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8" name="Rectangle 1037">
            <a:extLst>
              <a:ext uri="{FF2B5EF4-FFF2-40B4-BE49-F238E27FC236}">
                <a16:creationId xmlns:a16="http://schemas.microsoft.com/office/drawing/2014/main" id="{6769988F-9CB3-0E1C-7D11-5947193CDB43}"/>
              </a:ext>
            </a:extLst>
          </p:cNvPr>
          <p:cNvSpPr/>
          <p:nvPr/>
        </p:nvSpPr>
        <p:spPr>
          <a:xfrm>
            <a:off x="4709126" y="3302964"/>
            <a:ext cx="255520" cy="1541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9" name="Rectangle 1038">
            <a:extLst>
              <a:ext uri="{FF2B5EF4-FFF2-40B4-BE49-F238E27FC236}">
                <a16:creationId xmlns:a16="http://schemas.microsoft.com/office/drawing/2014/main" id="{1BC103E6-F0E1-B075-3A17-ED6A1A4D84E9}"/>
              </a:ext>
            </a:extLst>
          </p:cNvPr>
          <p:cNvSpPr/>
          <p:nvPr/>
        </p:nvSpPr>
        <p:spPr>
          <a:xfrm>
            <a:off x="3785587" y="3287099"/>
            <a:ext cx="241177" cy="1145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1" name="Rectangle 1040">
            <a:extLst>
              <a:ext uri="{FF2B5EF4-FFF2-40B4-BE49-F238E27FC236}">
                <a16:creationId xmlns:a16="http://schemas.microsoft.com/office/drawing/2014/main" id="{D15C39B4-9DC5-84A6-679E-FB591CE00ED1}"/>
              </a:ext>
            </a:extLst>
          </p:cNvPr>
          <p:cNvSpPr/>
          <p:nvPr/>
        </p:nvSpPr>
        <p:spPr>
          <a:xfrm>
            <a:off x="5297683" y="5413682"/>
            <a:ext cx="311716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2" name="Rectangle 1041">
            <a:extLst>
              <a:ext uri="{FF2B5EF4-FFF2-40B4-BE49-F238E27FC236}">
                <a16:creationId xmlns:a16="http://schemas.microsoft.com/office/drawing/2014/main" id="{83866890-D2D8-112A-24CD-CB84D483D1BA}"/>
              </a:ext>
            </a:extLst>
          </p:cNvPr>
          <p:cNvSpPr/>
          <p:nvPr/>
        </p:nvSpPr>
        <p:spPr>
          <a:xfrm>
            <a:off x="5346312" y="5426057"/>
            <a:ext cx="275402" cy="471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3" name="Rectangle 1042">
            <a:extLst>
              <a:ext uri="{FF2B5EF4-FFF2-40B4-BE49-F238E27FC236}">
                <a16:creationId xmlns:a16="http://schemas.microsoft.com/office/drawing/2014/main" id="{C96B19C2-9272-334D-F15D-14039B64A673}"/>
              </a:ext>
            </a:extLst>
          </p:cNvPr>
          <p:cNvSpPr/>
          <p:nvPr/>
        </p:nvSpPr>
        <p:spPr>
          <a:xfrm>
            <a:off x="5363781" y="5442651"/>
            <a:ext cx="311716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4" name="Rectangle 1043">
            <a:extLst>
              <a:ext uri="{FF2B5EF4-FFF2-40B4-BE49-F238E27FC236}">
                <a16:creationId xmlns:a16="http://schemas.microsoft.com/office/drawing/2014/main" id="{B59363F0-E89E-F190-FA2F-5BE5365A90C6}"/>
              </a:ext>
            </a:extLst>
          </p:cNvPr>
          <p:cNvSpPr/>
          <p:nvPr/>
        </p:nvSpPr>
        <p:spPr>
          <a:xfrm>
            <a:off x="5388676" y="5460589"/>
            <a:ext cx="208408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5" name="Rectangle 1044">
            <a:extLst>
              <a:ext uri="{FF2B5EF4-FFF2-40B4-BE49-F238E27FC236}">
                <a16:creationId xmlns:a16="http://schemas.microsoft.com/office/drawing/2014/main" id="{3EC13B2A-FD94-3076-7EA1-B57699A0C310}"/>
              </a:ext>
            </a:extLst>
          </p:cNvPr>
          <p:cNvSpPr/>
          <p:nvPr/>
        </p:nvSpPr>
        <p:spPr>
          <a:xfrm>
            <a:off x="4308133" y="5421148"/>
            <a:ext cx="311716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6" name="Rectangle 1045">
            <a:extLst>
              <a:ext uri="{FF2B5EF4-FFF2-40B4-BE49-F238E27FC236}">
                <a16:creationId xmlns:a16="http://schemas.microsoft.com/office/drawing/2014/main" id="{31A70FF1-C37E-A60C-07F7-D9D8BF750A75}"/>
              </a:ext>
            </a:extLst>
          </p:cNvPr>
          <p:cNvSpPr/>
          <p:nvPr/>
        </p:nvSpPr>
        <p:spPr>
          <a:xfrm>
            <a:off x="4358991" y="5442497"/>
            <a:ext cx="311716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7" name="Rectangle 1046">
            <a:extLst>
              <a:ext uri="{FF2B5EF4-FFF2-40B4-BE49-F238E27FC236}">
                <a16:creationId xmlns:a16="http://schemas.microsoft.com/office/drawing/2014/main" id="{1A3743BD-D2B0-87F9-73BC-300A192A10FA}"/>
              </a:ext>
            </a:extLst>
          </p:cNvPr>
          <p:cNvSpPr/>
          <p:nvPr/>
        </p:nvSpPr>
        <p:spPr>
          <a:xfrm>
            <a:off x="4403301" y="5459401"/>
            <a:ext cx="311716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8" name="Rectangle 1047">
            <a:extLst>
              <a:ext uri="{FF2B5EF4-FFF2-40B4-BE49-F238E27FC236}">
                <a16:creationId xmlns:a16="http://schemas.microsoft.com/office/drawing/2014/main" id="{153B56F4-F5A6-8747-0217-9127D9CCC0B7}"/>
              </a:ext>
            </a:extLst>
          </p:cNvPr>
          <p:cNvSpPr/>
          <p:nvPr/>
        </p:nvSpPr>
        <p:spPr>
          <a:xfrm>
            <a:off x="2589133" y="5385436"/>
            <a:ext cx="212478" cy="598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9" name="Rectangle 1048">
            <a:extLst>
              <a:ext uri="{FF2B5EF4-FFF2-40B4-BE49-F238E27FC236}">
                <a16:creationId xmlns:a16="http://schemas.microsoft.com/office/drawing/2014/main" id="{60A726C9-C415-417C-5AA6-1EC93B5C57E9}"/>
              </a:ext>
            </a:extLst>
          </p:cNvPr>
          <p:cNvSpPr/>
          <p:nvPr/>
        </p:nvSpPr>
        <p:spPr>
          <a:xfrm>
            <a:off x="2683312" y="5404936"/>
            <a:ext cx="212478" cy="598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0" name="Rectangle 1049">
            <a:extLst>
              <a:ext uri="{FF2B5EF4-FFF2-40B4-BE49-F238E27FC236}">
                <a16:creationId xmlns:a16="http://schemas.microsoft.com/office/drawing/2014/main" id="{C83C134F-9CF6-C5F9-6D71-2F455E7109D7}"/>
              </a:ext>
            </a:extLst>
          </p:cNvPr>
          <p:cNvSpPr/>
          <p:nvPr/>
        </p:nvSpPr>
        <p:spPr>
          <a:xfrm>
            <a:off x="2029765" y="4150427"/>
            <a:ext cx="363636" cy="931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1" name="Rectangle 1050">
            <a:extLst>
              <a:ext uri="{FF2B5EF4-FFF2-40B4-BE49-F238E27FC236}">
                <a16:creationId xmlns:a16="http://schemas.microsoft.com/office/drawing/2014/main" id="{E800D7F5-64E2-4FE7-5922-3373D7C6F88B}"/>
              </a:ext>
            </a:extLst>
          </p:cNvPr>
          <p:cNvSpPr/>
          <p:nvPr/>
        </p:nvSpPr>
        <p:spPr>
          <a:xfrm>
            <a:off x="2567326" y="3759074"/>
            <a:ext cx="363636" cy="931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2" name="Rectangle 1051">
            <a:extLst>
              <a:ext uri="{FF2B5EF4-FFF2-40B4-BE49-F238E27FC236}">
                <a16:creationId xmlns:a16="http://schemas.microsoft.com/office/drawing/2014/main" id="{1E4FFDB6-0391-70AF-C027-C43051A21B20}"/>
              </a:ext>
            </a:extLst>
          </p:cNvPr>
          <p:cNvSpPr/>
          <p:nvPr/>
        </p:nvSpPr>
        <p:spPr>
          <a:xfrm>
            <a:off x="2701290" y="3845493"/>
            <a:ext cx="239443" cy="71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53" name="Rectangle 1052">
            <a:extLst>
              <a:ext uri="{FF2B5EF4-FFF2-40B4-BE49-F238E27FC236}">
                <a16:creationId xmlns:a16="http://schemas.microsoft.com/office/drawing/2014/main" id="{5404ED20-1DEC-70B0-6D4D-C244B010F912}"/>
              </a:ext>
            </a:extLst>
          </p:cNvPr>
          <p:cNvSpPr/>
          <p:nvPr/>
        </p:nvSpPr>
        <p:spPr>
          <a:xfrm>
            <a:off x="2085210" y="2827548"/>
            <a:ext cx="255520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2073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c7de09d-9034-44c1-b462-c464fece204a}" enabled="0" method="" siteId="{9c7de09d-9034-44c1-b462-c464fece204a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66</TotalTime>
  <Words>126</Words>
  <Application>Microsoft Office PowerPoint</Application>
  <PresentationFormat>Widescreen</PresentationFormat>
  <Paragraphs>63</Paragraphs>
  <Slides>3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ore, Eric A (HSC)</dc:creator>
  <cp:lastModifiedBy>Moore, Eric A (HSC)</cp:lastModifiedBy>
  <cp:revision>64</cp:revision>
  <dcterms:created xsi:type="dcterms:W3CDTF">2024-11-30T14:25:14Z</dcterms:created>
  <dcterms:modified xsi:type="dcterms:W3CDTF">2026-02-03T17:15:40Z</dcterms:modified>
</cp:coreProperties>
</file>